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18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964CC-8924-4A30-9BA4-6E012D5131F2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0549-3760-43DC-9801-7045A08FA6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9907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964CC-8924-4A30-9BA4-6E012D5131F2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0549-3760-43DC-9801-7045A08FA6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85303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964CC-8924-4A30-9BA4-6E012D5131F2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0549-3760-43DC-9801-7045A08FA6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2480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964CC-8924-4A30-9BA4-6E012D5131F2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0549-3760-43DC-9801-7045A08FA6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1163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964CC-8924-4A30-9BA4-6E012D5131F2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0549-3760-43DC-9801-7045A08FA6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6861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964CC-8924-4A30-9BA4-6E012D5131F2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0549-3760-43DC-9801-7045A08FA6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5597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964CC-8924-4A30-9BA4-6E012D5131F2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0549-3760-43DC-9801-7045A08FA6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1972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964CC-8924-4A30-9BA4-6E012D5131F2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0549-3760-43DC-9801-7045A08FA6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2745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964CC-8924-4A30-9BA4-6E012D5131F2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0549-3760-43DC-9801-7045A08FA6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36665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964CC-8924-4A30-9BA4-6E012D5131F2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0549-3760-43DC-9801-7045A08FA6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25158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964CC-8924-4A30-9BA4-6E012D5131F2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0549-3760-43DC-9801-7045A08FA6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4212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964CC-8924-4A30-9BA4-6E012D5131F2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620549-3760-43DC-9801-7045A08FA60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9098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pic>
        <p:nvPicPr>
          <p:cNvPr id="4" name="Google Shape;94;p15"/>
          <p:cNvPicPr/>
          <p:nvPr/>
        </p:nvPicPr>
        <p:blipFill>
          <a:blip r:embed="rId2">
            <a:alphaModFix/>
          </a:blip>
          <a:stretch/>
        </p:blipFill>
        <p:spPr bwMode="auto">
          <a:xfrm>
            <a:off x="176271" y="1189166"/>
            <a:ext cx="11839458" cy="2158171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Google Shape;95;p15"/>
          <p:cNvSpPr txBox="1"/>
          <p:nvPr/>
        </p:nvSpPr>
        <p:spPr bwMode="auto">
          <a:xfrm>
            <a:off x="1637881" y="3825294"/>
            <a:ext cx="8676192" cy="10058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  <a:defRPr/>
            </a:pPr>
            <a:r>
              <a:rPr lang="fr-FR" sz="1500" b="1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Supplementary</a:t>
            </a:r>
            <a:r>
              <a:rPr lang="fr-FR" sz="1500" b="1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Figure S2.  </a:t>
            </a:r>
            <a:r>
              <a:rPr lang="fr-FR" sz="1500" b="0" i="1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Timeline</a:t>
            </a:r>
            <a:r>
              <a:rPr lang="fr-FR" sz="1500" b="0" i="1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of </a:t>
            </a:r>
            <a:r>
              <a:rPr lang="fr-FR" sz="1500" b="0" i="1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behavioral</a:t>
            </a:r>
            <a:r>
              <a:rPr lang="fr-FR" sz="1500" b="0" i="1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1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assessment</a:t>
            </a:r>
            <a:r>
              <a:rPr lang="fr-FR" sz="1500" b="0" i="1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.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After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astroglial</a:t>
            </a:r>
            <a:r>
              <a:rPr lang="fr-FR" sz="1500" b="0" i="0" u="none" strike="noStrike" cap="none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i="1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L</a:t>
            </a:r>
            <a:r>
              <a:rPr lang="fr-FR" sz="1500" b="0" i="1" u="none" strike="noStrike" cap="none" dirty="0" err="1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sr</a:t>
            </a:r>
            <a:r>
              <a:rPr lang="fr-FR" sz="1500" b="0" i="1" u="none" strike="noStrike" cap="none" dirty="0" smtClean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deletion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(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see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Supplementary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Figure 1),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behavioral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tests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were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performed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as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indicated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in the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timeline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(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numbers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indicate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age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 in </a:t>
            </a:r>
            <a:r>
              <a:rPr lang="fr-FR" sz="15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</a:rPr>
              <a:t>months</a:t>
            </a:r>
            <a:r>
              <a:rPr lang="fr-FR" sz="15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</a:rPr>
              <a:t>). </a:t>
            </a:r>
            <a:endParaRPr sz="15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</a:endParaRPr>
          </a:p>
          <a:p>
            <a:pPr marL="0" marR="0" lvl="0" indent="0" algn="just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  <a:defRPr/>
            </a:pPr>
            <a:endParaRPr sz="15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4066509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 xmlns:m="http://schemas.openxmlformats.org/officeDocument/2006/math" xmlns:w="http://schemas.openxmlformats.org/wordprocessingml/2006/main">
      <p:transition advClick="1"/>
    </mc:Fallback>
  </mc:AlternateContent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5</Words>
  <Application>Microsoft Office PowerPoint</Application>
  <PresentationFormat>Grand écran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U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Claudepierre</dc:creator>
  <cp:lastModifiedBy>Thomas Claudepierre</cp:lastModifiedBy>
  <cp:revision>3</cp:revision>
  <dcterms:created xsi:type="dcterms:W3CDTF">2022-01-28T21:56:04Z</dcterms:created>
  <dcterms:modified xsi:type="dcterms:W3CDTF">2022-02-04T17:57:12Z</dcterms:modified>
</cp:coreProperties>
</file>